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sldIdLst>
    <p:sldId id="272" r:id="rId2"/>
    <p:sldId id="273" r:id="rId3"/>
    <p:sldId id="275" r:id="rId4"/>
    <p:sldId id="257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25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/>
              <a:t>Kattintson ide az alcím mintájának szerkesztéséhez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4790F-8B28-468B-8221-23776173C858}" type="datetimeFigureOut">
              <a:rPr lang="hu-HU" smtClean="0"/>
              <a:t>2025. 09. 20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80DD2-72C2-4570-A33F-4EB3A2486BD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75452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4790F-8B28-468B-8221-23776173C858}" type="datetimeFigureOut">
              <a:rPr lang="hu-HU" smtClean="0"/>
              <a:t>2025. 09. 20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80DD2-72C2-4570-A33F-4EB3A2486BD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096870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4790F-8B28-468B-8221-23776173C858}" type="datetimeFigureOut">
              <a:rPr lang="hu-HU" smtClean="0"/>
              <a:t>2025. 09. 20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80DD2-72C2-4570-A33F-4EB3A2486BD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4198528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4790F-8B28-468B-8221-23776173C858}" type="datetimeFigureOut">
              <a:rPr lang="hu-HU" smtClean="0"/>
              <a:t>2025. 09. 20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80DD2-72C2-4570-A33F-4EB3A2486BD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06943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4790F-8B28-468B-8221-23776173C858}" type="datetimeFigureOut">
              <a:rPr lang="hu-HU" smtClean="0"/>
              <a:t>2025. 09. 20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80DD2-72C2-4570-A33F-4EB3A2486BD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63838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4790F-8B28-468B-8221-23776173C858}" type="datetimeFigureOut">
              <a:rPr lang="hu-HU" smtClean="0"/>
              <a:t>2025. 09. 20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80DD2-72C2-4570-A33F-4EB3A2486BD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06970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4790F-8B28-468B-8221-23776173C858}" type="datetimeFigureOut">
              <a:rPr lang="hu-HU" smtClean="0"/>
              <a:t>2025. 09. 20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80DD2-72C2-4570-A33F-4EB3A2486BD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2850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4790F-8B28-468B-8221-23776173C858}" type="datetimeFigureOut">
              <a:rPr lang="hu-HU" smtClean="0"/>
              <a:t>2025. 09. 20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80DD2-72C2-4570-A33F-4EB3A2486BD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570805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4790F-8B28-468B-8221-23776173C858}" type="datetimeFigureOut">
              <a:rPr lang="hu-HU" smtClean="0"/>
              <a:t>2025. 09. 20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80DD2-72C2-4570-A33F-4EB3A2486BD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44299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4790F-8B28-468B-8221-23776173C858}" type="datetimeFigureOut">
              <a:rPr lang="hu-HU" smtClean="0"/>
              <a:t>2025. 09. 20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80DD2-72C2-4570-A33F-4EB3A2486BD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12697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4790F-8B28-468B-8221-23776173C858}" type="datetimeFigureOut">
              <a:rPr lang="hu-HU" smtClean="0"/>
              <a:t>2025. 09. 20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80DD2-72C2-4570-A33F-4EB3A2486BD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609250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24790F-8B28-468B-8221-23776173C858}" type="datetimeFigureOut">
              <a:rPr lang="hu-HU" smtClean="0"/>
              <a:t>2025. 09. 20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80DD2-72C2-4570-A33F-4EB3A2486BD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7990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zövegdoboz 1">
            <a:extLst>
              <a:ext uri="{FF2B5EF4-FFF2-40B4-BE49-F238E27FC236}">
                <a16:creationId xmlns:a16="http://schemas.microsoft.com/office/drawing/2014/main" id="{7C38A759-5538-92C6-7E20-B8475FF18597}"/>
              </a:ext>
            </a:extLst>
          </p:cNvPr>
          <p:cNvSpPr txBox="1"/>
          <p:nvPr/>
        </p:nvSpPr>
        <p:spPr>
          <a:xfrm>
            <a:off x="920048" y="379364"/>
            <a:ext cx="9733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hu-HU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</a:t>
            </a:r>
          </a:p>
        </p:txBody>
      </p:sp>
      <p:graphicFrame>
        <p:nvGraphicFramePr>
          <p:cNvPr id="3" name="Objektum 2">
            <a:extLst>
              <a:ext uri="{FF2B5EF4-FFF2-40B4-BE49-F238E27FC236}">
                <a16:creationId xmlns:a16="http://schemas.microsoft.com/office/drawing/2014/main" id="{6074314F-11E0-7A73-AC05-8D63F01C553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95490666"/>
              </p:ext>
            </p:extLst>
          </p:nvPr>
        </p:nvGraphicFramePr>
        <p:xfrm>
          <a:off x="909480" y="4435386"/>
          <a:ext cx="2596217" cy="16690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818348" imgH="3096390" progId="Prism9.Document">
                  <p:embed/>
                </p:oleObj>
              </mc:Choice>
              <mc:Fallback>
                <p:oleObj name="Prism 9" r:id="rId2" imgW="4818348" imgH="309639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09480" y="4435386"/>
                        <a:ext cx="2596217" cy="16690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um 4">
            <a:extLst>
              <a:ext uri="{FF2B5EF4-FFF2-40B4-BE49-F238E27FC236}">
                <a16:creationId xmlns:a16="http://schemas.microsoft.com/office/drawing/2014/main" id="{CCB762B6-6E41-ACC8-51CF-A0B572FD50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90290090"/>
              </p:ext>
            </p:extLst>
          </p:nvPr>
        </p:nvGraphicFramePr>
        <p:xfrm>
          <a:off x="3654350" y="4424170"/>
          <a:ext cx="2597390" cy="16843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781633" imgH="3101069" progId="Prism9.Document">
                  <p:embed/>
                </p:oleObj>
              </mc:Choice>
              <mc:Fallback>
                <p:oleObj name="Prism 9" r:id="rId4" imgW="4781633" imgH="310106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654350" y="4424170"/>
                        <a:ext cx="2597390" cy="16843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um 5">
            <a:extLst>
              <a:ext uri="{FF2B5EF4-FFF2-40B4-BE49-F238E27FC236}">
                <a16:creationId xmlns:a16="http://schemas.microsoft.com/office/drawing/2014/main" id="{0789C634-A1A1-E914-3719-C16B07D282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3593931"/>
              </p:ext>
            </p:extLst>
          </p:nvPr>
        </p:nvGraphicFramePr>
        <p:xfrm>
          <a:off x="907660" y="6400776"/>
          <a:ext cx="2451502" cy="14029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854703" imgH="2777824" progId="Prism9.Document">
                  <p:embed/>
                </p:oleObj>
              </mc:Choice>
              <mc:Fallback>
                <p:oleObj name="Prism 9" r:id="rId6" imgW="4854703" imgH="277782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907660" y="6400776"/>
                        <a:ext cx="2451502" cy="14029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um 6">
            <a:extLst>
              <a:ext uri="{FF2B5EF4-FFF2-40B4-BE49-F238E27FC236}">
                <a16:creationId xmlns:a16="http://schemas.microsoft.com/office/drawing/2014/main" id="{60C7B380-4895-CDBE-45BA-F738E0386A2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04618643"/>
              </p:ext>
            </p:extLst>
          </p:nvPr>
        </p:nvGraphicFramePr>
        <p:xfrm>
          <a:off x="3611506" y="6337012"/>
          <a:ext cx="2628217" cy="15000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4870181" imgH="2779624" progId="Prism9.Document">
                  <p:embed/>
                </p:oleObj>
              </mc:Choice>
              <mc:Fallback>
                <p:oleObj name="Prism 9" r:id="rId8" imgW="4870181" imgH="277962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611506" y="6337012"/>
                        <a:ext cx="2628217" cy="15000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ktum 7">
            <a:extLst>
              <a:ext uri="{FF2B5EF4-FFF2-40B4-BE49-F238E27FC236}">
                <a16:creationId xmlns:a16="http://schemas.microsoft.com/office/drawing/2014/main" id="{55554DC4-DB7C-4870-F9D7-FA11DB9B51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91687608"/>
              </p:ext>
            </p:extLst>
          </p:nvPr>
        </p:nvGraphicFramePr>
        <p:xfrm>
          <a:off x="891393" y="2648340"/>
          <a:ext cx="2627865" cy="16221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4850384" imgH="2994521" progId="Prism9.Document">
                  <p:embed/>
                </p:oleObj>
              </mc:Choice>
              <mc:Fallback>
                <p:oleObj name="Prism 9" r:id="rId10" imgW="4850384" imgH="299452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91393" y="2648340"/>
                        <a:ext cx="2627865" cy="16221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um 8">
            <a:extLst>
              <a:ext uri="{FF2B5EF4-FFF2-40B4-BE49-F238E27FC236}">
                <a16:creationId xmlns:a16="http://schemas.microsoft.com/office/drawing/2014/main" id="{00B5F40C-C310-C848-2479-45A094647B0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7221684"/>
              </p:ext>
            </p:extLst>
          </p:nvPr>
        </p:nvGraphicFramePr>
        <p:xfrm>
          <a:off x="3614369" y="2805665"/>
          <a:ext cx="2571603" cy="14557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4865502" imgH="2753706" progId="Prism9.Document">
                  <p:embed/>
                </p:oleObj>
              </mc:Choice>
              <mc:Fallback>
                <p:oleObj name="Prism 9" r:id="rId12" imgW="4865502" imgH="275370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614369" y="2805665"/>
                        <a:ext cx="2571603" cy="14557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um 9">
            <a:extLst>
              <a:ext uri="{FF2B5EF4-FFF2-40B4-BE49-F238E27FC236}">
                <a16:creationId xmlns:a16="http://schemas.microsoft.com/office/drawing/2014/main" id="{059263AF-EE88-E699-B09C-2479C95A510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6456572"/>
              </p:ext>
            </p:extLst>
          </p:nvPr>
        </p:nvGraphicFramePr>
        <p:xfrm>
          <a:off x="920048" y="1004505"/>
          <a:ext cx="2669544" cy="15402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4774074" imgH="2753706" progId="Prism9.Document">
                  <p:embed/>
                </p:oleObj>
              </mc:Choice>
              <mc:Fallback>
                <p:oleObj name="Prism 9" r:id="rId14" imgW="4774074" imgH="275370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920048" y="1004505"/>
                        <a:ext cx="2669544" cy="15402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um 10">
            <a:extLst>
              <a:ext uri="{FF2B5EF4-FFF2-40B4-BE49-F238E27FC236}">
                <a16:creationId xmlns:a16="http://schemas.microsoft.com/office/drawing/2014/main" id="{E64B395C-C3ED-1246-B8A3-8B8086C9E5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638486"/>
              </p:ext>
            </p:extLst>
          </p:nvPr>
        </p:nvGraphicFramePr>
        <p:xfrm>
          <a:off x="3639144" y="1005205"/>
          <a:ext cx="2669545" cy="1535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4789192" imgH="2753706" progId="Prism9.Document">
                  <p:embed/>
                </p:oleObj>
              </mc:Choice>
              <mc:Fallback>
                <p:oleObj name="Prism 9" r:id="rId16" imgW="4789192" imgH="275370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639144" y="1005205"/>
                        <a:ext cx="2669545" cy="1535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Szövegdoboz 12">
            <a:extLst>
              <a:ext uri="{FF2B5EF4-FFF2-40B4-BE49-F238E27FC236}">
                <a16:creationId xmlns:a16="http://schemas.microsoft.com/office/drawing/2014/main" id="{DBD0AF75-472B-DCF7-3A4C-EB67AE01C8A3}"/>
              </a:ext>
            </a:extLst>
          </p:cNvPr>
          <p:cNvSpPr txBox="1"/>
          <p:nvPr/>
        </p:nvSpPr>
        <p:spPr>
          <a:xfrm>
            <a:off x="891393" y="7945948"/>
            <a:ext cx="5652040" cy="14555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886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emotherapy and tumor cell co-culture influence the M1/M2 gene expression profile of M0 macrophages</a:t>
            </a:r>
            <a:endParaRPr lang="hu-HU" sz="886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86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4⁺ monocytes were cultured with 50 ng/ml recombinant M-CSF for 5 days to differentiate into M0 macrophages.</a:t>
            </a:r>
            <a:br>
              <a:rPr lang="en-US" sz="886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86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crophages were co-cultured with MDA-MB-231 or HeLa tumor cells at a 1:1 ratio for 24 hours, followed by treatment with doxorubicin or </a:t>
            </a:r>
            <a:r>
              <a:rPr lang="en-US" sz="886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irubicin</a:t>
            </a:r>
            <a:r>
              <a:rPr lang="en-US" sz="886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an additional 24 hours. Expression levels of CD80, CD86, Arg1, and </a:t>
            </a:r>
            <a:r>
              <a:rPr lang="en-US" sz="886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ARγ</a:t>
            </a:r>
            <a:r>
              <a:rPr lang="en-US" sz="886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measured by quantitative PCR.</a:t>
            </a:r>
            <a:r>
              <a:rPr lang="hu-HU" sz="886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86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lative amount of mRNA was obtained by normalizing to the H36B4 housekeeping gene in each experiment. Results are presented as mean ± SD from at least three independent experiments. Statistical analysis was performed using ANOVA followed by Bonferroni’s post hoc test. Differences were considered statistically significant at p &lt; 0.05. Statistical differences are indicated as </a:t>
            </a:r>
            <a:r>
              <a:rPr lang="nn-NO" sz="886" dirty="0">
                <a:latin typeface="Times New Roman" panose="02020603050405020304" pitchFamily="18" charset="0"/>
                <a:cs typeface="Times New Roman" panose="02020603050405020304" pitchFamily="18" charset="0"/>
              </a:rPr>
              <a:t>*p &lt; 0.05</a:t>
            </a:r>
            <a:r>
              <a:rPr lang="hu-HU" sz="886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nn-NO" sz="886" dirty="0">
                <a:latin typeface="Times New Roman" panose="02020603050405020304" pitchFamily="18" charset="0"/>
                <a:cs typeface="Times New Roman" panose="02020603050405020304" pitchFamily="18" charset="0"/>
              </a:rPr>
              <a:t> ****p &lt; 0.0001 </a:t>
            </a:r>
            <a:r>
              <a:rPr lang="en-US" sz="886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rsus treated counterparts.</a:t>
            </a:r>
            <a:endParaRPr lang="hu-HU" sz="88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hu-HU" sz="886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Szövegdoboz 14">
            <a:extLst>
              <a:ext uri="{FF2B5EF4-FFF2-40B4-BE49-F238E27FC236}">
                <a16:creationId xmlns:a16="http://schemas.microsoft.com/office/drawing/2014/main" id="{326C11DF-127E-15B5-4FF5-B359FC7BC5A2}"/>
              </a:ext>
            </a:extLst>
          </p:cNvPr>
          <p:cNvSpPr txBox="1"/>
          <p:nvPr/>
        </p:nvSpPr>
        <p:spPr>
          <a:xfrm>
            <a:off x="2892001" y="687141"/>
            <a:ext cx="12273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hu-HU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0 </a:t>
            </a:r>
            <a:r>
              <a:rPr lang="hu-HU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endParaRPr lang="hu-HU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Szövegdoboz 15">
            <a:extLst>
              <a:ext uri="{FF2B5EF4-FFF2-40B4-BE49-F238E27FC236}">
                <a16:creationId xmlns:a16="http://schemas.microsoft.com/office/drawing/2014/main" id="{4069F8C9-0186-8CF8-3A8F-EDC7F1B8D188}"/>
              </a:ext>
            </a:extLst>
          </p:cNvPr>
          <p:cNvSpPr txBox="1"/>
          <p:nvPr/>
        </p:nvSpPr>
        <p:spPr>
          <a:xfrm>
            <a:off x="2892001" y="2419912"/>
            <a:ext cx="12273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hu-HU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6 </a:t>
            </a:r>
            <a:r>
              <a:rPr lang="hu-HU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endParaRPr lang="hu-HU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Szövegdoboz 16">
            <a:extLst>
              <a:ext uri="{FF2B5EF4-FFF2-40B4-BE49-F238E27FC236}">
                <a16:creationId xmlns:a16="http://schemas.microsoft.com/office/drawing/2014/main" id="{4D1615E0-4212-CDEE-8F32-18F9B7C757E1}"/>
              </a:ext>
            </a:extLst>
          </p:cNvPr>
          <p:cNvSpPr txBox="1"/>
          <p:nvPr/>
        </p:nvSpPr>
        <p:spPr>
          <a:xfrm>
            <a:off x="2905562" y="4200199"/>
            <a:ext cx="12273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hu-HU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g1 </a:t>
            </a:r>
            <a:r>
              <a:rPr lang="hu-HU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endParaRPr lang="hu-HU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Szövegdoboz 17">
            <a:extLst>
              <a:ext uri="{FF2B5EF4-FFF2-40B4-BE49-F238E27FC236}">
                <a16:creationId xmlns:a16="http://schemas.microsoft.com/office/drawing/2014/main" id="{D1D9B5D7-DC1E-B410-6622-D4D79B025E8C}"/>
              </a:ext>
            </a:extLst>
          </p:cNvPr>
          <p:cNvSpPr txBox="1"/>
          <p:nvPr/>
        </p:nvSpPr>
        <p:spPr>
          <a:xfrm>
            <a:off x="2860433" y="6030232"/>
            <a:ext cx="143918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ARγ</a:t>
            </a:r>
            <a:r>
              <a:rPr lang="hu-HU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endParaRPr lang="hu-HU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63813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Csoportba foglalás 5">
            <a:extLst>
              <a:ext uri="{FF2B5EF4-FFF2-40B4-BE49-F238E27FC236}">
                <a16:creationId xmlns:a16="http://schemas.microsoft.com/office/drawing/2014/main" id="{F0F40703-A244-F186-4DAA-9AC5B20284A0}"/>
              </a:ext>
            </a:extLst>
          </p:cNvPr>
          <p:cNvGrpSpPr/>
          <p:nvPr/>
        </p:nvGrpSpPr>
        <p:grpSpPr>
          <a:xfrm>
            <a:off x="201706" y="762000"/>
            <a:ext cx="6454588" cy="8382000"/>
            <a:chOff x="201706" y="762000"/>
            <a:chExt cx="6454588" cy="8382000"/>
          </a:xfrm>
        </p:grpSpPr>
        <p:pic>
          <p:nvPicPr>
            <p:cNvPr id="9" name="Kép 8">
              <a:extLst>
                <a:ext uri="{FF2B5EF4-FFF2-40B4-BE49-F238E27FC236}">
                  <a16:creationId xmlns:a16="http://schemas.microsoft.com/office/drawing/2014/main" id="{517ED55E-2784-5F92-8A09-4AABECFBCB8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7096" y="762000"/>
              <a:ext cx="6083808" cy="8382000"/>
            </a:xfrm>
            <a:prstGeom prst="rect">
              <a:avLst/>
            </a:prstGeom>
          </p:spPr>
        </p:pic>
        <p:sp>
          <p:nvSpPr>
            <p:cNvPr id="3" name="Téglalap 2">
              <a:extLst>
                <a:ext uri="{FF2B5EF4-FFF2-40B4-BE49-F238E27FC236}">
                  <a16:creationId xmlns:a16="http://schemas.microsoft.com/office/drawing/2014/main" id="{F8F6E544-4B7B-6E30-AA6E-EC69D23619F2}"/>
                </a:ext>
              </a:extLst>
            </p:cNvPr>
            <p:cNvSpPr/>
            <p:nvPr/>
          </p:nvSpPr>
          <p:spPr>
            <a:xfrm>
              <a:off x="201706" y="1277471"/>
              <a:ext cx="6454588" cy="533848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  <p:pic>
          <p:nvPicPr>
            <p:cNvPr id="2" name="Kép 1">
              <a:extLst>
                <a:ext uri="{FF2B5EF4-FFF2-40B4-BE49-F238E27FC236}">
                  <a16:creationId xmlns:a16="http://schemas.microsoft.com/office/drawing/2014/main" id="{4B795094-C87D-0034-B107-205ACA553B8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5787" y="1179421"/>
              <a:ext cx="6326425" cy="5534580"/>
            </a:xfrm>
            <a:prstGeom prst="rect">
              <a:avLst/>
            </a:prstGeom>
          </p:spPr>
        </p:pic>
        <p:sp>
          <p:nvSpPr>
            <p:cNvPr id="4" name="Téglalap 3">
              <a:extLst>
                <a:ext uri="{FF2B5EF4-FFF2-40B4-BE49-F238E27FC236}">
                  <a16:creationId xmlns:a16="http://schemas.microsoft.com/office/drawing/2014/main" id="{575F29ED-7611-C612-B508-B63601992001}"/>
                </a:ext>
              </a:extLst>
            </p:cNvPr>
            <p:cNvSpPr/>
            <p:nvPr/>
          </p:nvSpPr>
          <p:spPr>
            <a:xfrm>
              <a:off x="387096" y="8710102"/>
              <a:ext cx="5952744" cy="4174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  <p:sp>
          <p:nvSpPr>
            <p:cNvPr id="5" name="Téglalap 4">
              <a:extLst>
                <a:ext uri="{FF2B5EF4-FFF2-40B4-BE49-F238E27FC236}">
                  <a16:creationId xmlns:a16="http://schemas.microsoft.com/office/drawing/2014/main" id="{9A5F0768-8854-FC1B-9F92-78568C5CC5D2}"/>
                </a:ext>
              </a:extLst>
            </p:cNvPr>
            <p:cNvSpPr/>
            <p:nvPr/>
          </p:nvSpPr>
          <p:spPr>
            <a:xfrm>
              <a:off x="3787140" y="8533941"/>
              <a:ext cx="2552700" cy="4174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</p:grpSp>
      <p:sp>
        <p:nvSpPr>
          <p:cNvPr id="7" name="Szövegdoboz 3">
            <a:extLst>
              <a:ext uri="{FF2B5EF4-FFF2-40B4-BE49-F238E27FC236}">
                <a16:creationId xmlns:a16="http://schemas.microsoft.com/office/drawing/2014/main" id="{8BB47D62-5D81-38CA-A5CD-0538B8B0D0ED}"/>
              </a:ext>
            </a:extLst>
          </p:cNvPr>
          <p:cNvSpPr txBox="1"/>
          <p:nvPr/>
        </p:nvSpPr>
        <p:spPr>
          <a:xfrm>
            <a:off x="1533525" y="716356"/>
            <a:ext cx="116205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hu-HU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hu-HU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6582177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42032FB-5EED-8453-62AD-1940E019CDF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Kép 2" descr="A képen szöveg, diagram, Műszaki rajz, Tervrajz látható&#10;&#10;Előfordulhat, hogy a mesterséges intelligencia által létrehozott tartalom helytelen.">
            <a:extLst>
              <a:ext uri="{FF2B5EF4-FFF2-40B4-BE49-F238E27FC236}">
                <a16:creationId xmlns:a16="http://schemas.microsoft.com/office/drawing/2014/main" id="{3FAACED0-CFAA-A2F6-F7FA-1C091F0E5F9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59"/>
          <a:stretch>
            <a:fillRect/>
          </a:stretch>
        </p:blipFill>
        <p:spPr>
          <a:xfrm>
            <a:off x="64008" y="577120"/>
            <a:ext cx="6793992" cy="8532067"/>
          </a:xfrm>
          <a:prstGeom prst="rect">
            <a:avLst/>
          </a:prstGeom>
        </p:spPr>
      </p:pic>
      <p:sp>
        <p:nvSpPr>
          <p:cNvPr id="2" name="Szövegdoboz 1">
            <a:extLst>
              <a:ext uri="{FF2B5EF4-FFF2-40B4-BE49-F238E27FC236}">
                <a16:creationId xmlns:a16="http://schemas.microsoft.com/office/drawing/2014/main" id="{B71B9CDD-2B34-45A3-C7E0-BE2F7DA3AA9F}"/>
              </a:ext>
            </a:extLst>
          </p:cNvPr>
          <p:cNvSpPr txBox="1"/>
          <p:nvPr/>
        </p:nvSpPr>
        <p:spPr>
          <a:xfrm>
            <a:off x="128497" y="8279763"/>
            <a:ext cx="6665495" cy="13619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buNone/>
            </a:pPr>
            <a:r>
              <a:rPr lang="hu-HU" sz="9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ating</a:t>
            </a:r>
            <a:r>
              <a:rPr lang="hu-HU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hu-HU" sz="9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trategy</a:t>
            </a:r>
            <a:r>
              <a:rPr lang="hu-HU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of </a:t>
            </a:r>
            <a:r>
              <a:rPr lang="hu-HU" sz="9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</a:t>
            </a:r>
            <a:r>
              <a:rPr lang="hu-HU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hu-HU" sz="900" b="1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eath</a:t>
            </a:r>
            <a:r>
              <a:rPr lang="hu-HU" sz="9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hu-HU" sz="900" b="1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easurements</a:t>
            </a:r>
            <a:r>
              <a:rPr lang="hu-HU" sz="9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in co-</a:t>
            </a:r>
            <a:r>
              <a:rPr lang="hu-HU" sz="900" b="1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ulture</a:t>
            </a:r>
            <a:r>
              <a:rPr lang="hu-HU" sz="9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hu-HU" sz="900" b="1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ystems</a:t>
            </a:r>
            <a:endParaRPr lang="hu-HU" sz="9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buNone/>
            </a:pPr>
            <a:r>
              <a:rPr lang="en-US" sz="9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ffect of macrophages on the chemosensitivity of tumor cell lines.</a:t>
            </a:r>
            <a:r>
              <a:rPr lang="en-US" sz="9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9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D14</a:t>
            </a:r>
            <a:r>
              <a:rPr lang="en-US" sz="900" i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sz="9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onocytes were cultured with 50 ng/mL recombinant M-CSF for 5 days to generate M0 macrophages. In vitro-differentiated human M0, M1, and M2 macrophages were loaded with 10 ng/mL </a:t>
            </a:r>
            <a:r>
              <a:rPr lang="en-US" sz="900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Tracker</a:t>
            </a:r>
            <a:r>
              <a:rPr lang="en-US" sz="9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™ Green CMFDA dye and incubated for 30 min. After extensive washing, macrophages were co-cultured with unlabeled (</a:t>
            </a:r>
            <a:r>
              <a:rPr lang="en-US" sz="9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9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MDA-MB-231 or (</a:t>
            </a:r>
            <a:r>
              <a:rPr lang="en-US" sz="9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9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</a:t>
            </a:r>
            <a:r>
              <a:rPr lang="en-US" sz="105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9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eLa tumor cell lines at a 1:1 ratio for 24 h. Co-cultures were then treated with </a:t>
            </a:r>
            <a:r>
              <a:rPr lang="en-US" sz="900" i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chemotherapeutic drugs (doxorubicin or </a:t>
            </a:r>
            <a:r>
              <a:rPr lang="en-US" sz="900" i="1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pirubicin</a:t>
            </a:r>
            <a:r>
              <a:rPr lang="en-US" sz="900" i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for an additional 24 h. Tumor cell death was assessed by propidium iodide (PI) staining</a:t>
            </a:r>
            <a:r>
              <a:rPr lang="hu-HU" sz="900" i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</a:p>
          <a:p>
            <a:pPr algn="just">
              <a:buNone/>
            </a:pPr>
            <a:r>
              <a:rPr lang="en-US" sz="900" b="1" i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anel A </a:t>
            </a:r>
            <a:r>
              <a:rPr lang="en-US" sz="900" i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hows the size and granularity of M0 macrophages and tumor cell lines in mono- and co-cultures.</a:t>
            </a:r>
            <a:r>
              <a:rPr lang="hu-HU" sz="900" i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900" b="1" i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anel B </a:t>
            </a:r>
            <a:r>
              <a:rPr lang="en-US" sz="900" i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epicts the gating of M0 macrophages stained with </a:t>
            </a:r>
            <a:r>
              <a:rPr lang="en-US" sz="900" i="1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Tracker</a:t>
            </a:r>
            <a:r>
              <a:rPr lang="en-US" sz="900" i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™ Green CMFDA dye in mono- and co-cultures.</a:t>
            </a:r>
            <a:r>
              <a:rPr lang="hu-HU" sz="900" i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900" b="1" i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anel C </a:t>
            </a:r>
            <a:r>
              <a:rPr lang="en-US" sz="900" i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hows histograms illustrating the gating strategy for propidium iodide (PI)-positive cells.</a:t>
            </a:r>
            <a:endParaRPr lang="hu-HU" sz="900" i="1" dirty="0">
              <a:solidFill>
                <a:srgbClr val="000000"/>
              </a:solidFill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zövegdoboz 3">
            <a:extLst>
              <a:ext uri="{FF2B5EF4-FFF2-40B4-BE49-F238E27FC236}">
                <a16:creationId xmlns:a16="http://schemas.microsoft.com/office/drawing/2014/main" id="{DEC771FB-5464-961A-7B06-CA05CBADEE66}"/>
              </a:ext>
            </a:extLst>
          </p:cNvPr>
          <p:cNvSpPr txBox="1"/>
          <p:nvPr/>
        </p:nvSpPr>
        <p:spPr>
          <a:xfrm>
            <a:off x="297155" y="423231"/>
            <a:ext cx="973343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hu-HU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.</a:t>
            </a:r>
          </a:p>
        </p:txBody>
      </p:sp>
    </p:spTree>
    <p:extLst>
      <p:ext uri="{BB962C8B-B14F-4D97-AF65-F5344CB8AC3E}">
        <p14:creationId xmlns:p14="http://schemas.microsoft.com/office/powerpoint/2010/main" val="29162937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Kép 15" descr="A képen szöveg, diagram, Tervrajz, Műszaki rajz látható&#10;&#10;Előfordulhat, hogy a mesterséges intelligencia által létrehozott tartalom helytelen.">
            <a:extLst>
              <a:ext uri="{FF2B5EF4-FFF2-40B4-BE49-F238E27FC236}">
                <a16:creationId xmlns:a16="http://schemas.microsoft.com/office/drawing/2014/main" id="{091043E2-0B5C-EDA7-B431-D0FE615AA60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241"/>
          <a:stretch>
            <a:fillRect/>
          </a:stretch>
        </p:blipFill>
        <p:spPr>
          <a:xfrm>
            <a:off x="0" y="397239"/>
            <a:ext cx="6858000" cy="8495248"/>
          </a:xfrm>
          <a:prstGeom prst="rect">
            <a:avLst/>
          </a:prstGeom>
        </p:spPr>
      </p:pic>
      <p:sp>
        <p:nvSpPr>
          <p:cNvPr id="3" name="Szövegdoboz 2">
            <a:extLst>
              <a:ext uri="{FF2B5EF4-FFF2-40B4-BE49-F238E27FC236}">
                <a16:creationId xmlns:a16="http://schemas.microsoft.com/office/drawing/2014/main" id="{97E05422-6E5C-0DC9-5652-4384C8EF56DA}"/>
              </a:ext>
            </a:extLst>
          </p:cNvPr>
          <p:cNvSpPr txBox="1"/>
          <p:nvPr/>
        </p:nvSpPr>
        <p:spPr>
          <a:xfrm>
            <a:off x="192505" y="8002445"/>
            <a:ext cx="6665495" cy="13388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buNone/>
            </a:pPr>
            <a:r>
              <a:rPr lang="hu-HU" sz="900" b="1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ating</a:t>
            </a:r>
            <a:r>
              <a:rPr lang="hu-HU" sz="9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hu-HU" sz="900" b="1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trategy</a:t>
            </a:r>
            <a:r>
              <a:rPr lang="hu-HU" sz="9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of  </a:t>
            </a:r>
            <a:r>
              <a:rPr lang="hu-HU" sz="900" b="1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</a:t>
            </a:r>
            <a:r>
              <a:rPr lang="hu-HU" sz="9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hu-HU" sz="900" b="1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rface</a:t>
            </a:r>
            <a:r>
              <a:rPr lang="hu-HU" sz="9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hu-HU" sz="900" b="1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xpression</a:t>
            </a:r>
            <a:r>
              <a:rPr lang="hu-HU" sz="9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in co-</a:t>
            </a:r>
            <a:r>
              <a:rPr lang="hu-HU" sz="900" b="1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ulture</a:t>
            </a:r>
            <a:r>
              <a:rPr lang="hu-HU" sz="9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hu-HU" sz="900" b="1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ystem</a:t>
            </a:r>
            <a:endParaRPr lang="hu-HU" sz="9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buNone/>
            </a:pPr>
            <a:r>
              <a:rPr lang="en-US" sz="9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o-culturing macrophages with tumor cells and treating them with chemotherapeutic agents modifies the pattern of cell surface marker expression. CD14</a:t>
            </a:r>
            <a:r>
              <a:rPr lang="en-US" sz="9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hu-HU" sz="900" i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9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onocytes were cultured with 50 ng/mL recombinant M-CSF for 5 days to generate M0 macrophages. These macrophages were labeled with 10 ng/mL </a:t>
            </a:r>
            <a:r>
              <a:rPr lang="en-US" sz="9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Tracker</a:t>
            </a:r>
            <a:r>
              <a:rPr lang="en-US" sz="9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™ Green CMFDA dye and were co-cultured with unlabeled MDA-MB-231 or HeLa cell lines at a 1:1 ratio for 24 h. Following this incubation, cells were treated with chemotherapeutic agents (either doxorubicin or </a:t>
            </a:r>
            <a:r>
              <a:rPr lang="en-US" sz="9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pirubicin</a:t>
            </a:r>
            <a:r>
              <a:rPr lang="en-US" sz="9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for 24 h. Cell surface expression of CD206, CD163, CD209, and CD86 on macrophages was analyzed by flow cytometer. </a:t>
            </a:r>
            <a:endParaRPr lang="hu-HU" sz="900" i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buNone/>
            </a:pPr>
            <a:r>
              <a:rPr lang="en-US" sz="900" b="1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anel A </a:t>
            </a:r>
            <a:r>
              <a:rPr lang="en-US" sz="9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hows the size and granularity of M0 macrophages and tumor cell lines in mono- and co-cultures.</a:t>
            </a:r>
            <a:r>
              <a:rPr lang="hu-HU" sz="9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900" b="1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anel B</a:t>
            </a:r>
            <a:r>
              <a:rPr lang="en-US" sz="9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depicts the gating of M0 macrophages stained with </a:t>
            </a:r>
            <a:r>
              <a:rPr lang="en-US" sz="900" i="1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Tracker</a:t>
            </a:r>
            <a:r>
              <a:rPr lang="en-US" sz="9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™ Green CMFDA dye in mono- and co-cultures.</a:t>
            </a:r>
            <a:r>
              <a:rPr lang="hu-HU" sz="9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900" b="1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anel C</a:t>
            </a:r>
            <a:r>
              <a:rPr lang="en-US" sz="9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presents histograms illustrating the gating strategy for CD209/DC-SIGN-phycoerythrin (PE), CD86-PE, CD163-PE, and CD206-allophycocyanin (APC) positive macrophages.</a:t>
            </a:r>
            <a:endParaRPr lang="hu-HU" sz="900" i="1" dirty="0">
              <a:solidFill>
                <a:srgbClr val="000000"/>
              </a:solidFill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zövegdoboz 3">
            <a:extLst>
              <a:ext uri="{FF2B5EF4-FFF2-40B4-BE49-F238E27FC236}">
                <a16:creationId xmlns:a16="http://schemas.microsoft.com/office/drawing/2014/main" id="{17F088B5-DF44-A633-08A8-31A154CD1F76}"/>
              </a:ext>
            </a:extLst>
          </p:cNvPr>
          <p:cNvSpPr txBox="1"/>
          <p:nvPr/>
        </p:nvSpPr>
        <p:spPr>
          <a:xfrm>
            <a:off x="327135" y="89462"/>
            <a:ext cx="973343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hu-HU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.</a:t>
            </a:r>
          </a:p>
        </p:txBody>
      </p:sp>
    </p:spTree>
    <p:extLst>
      <p:ext uri="{BB962C8B-B14F-4D97-AF65-F5344CB8AC3E}">
        <p14:creationId xmlns:p14="http://schemas.microsoft.com/office/powerpoint/2010/main" val="9072692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– 2022 téma">
  <a:themeElements>
    <a:clrScheme name="Office 2013 – 2022 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– 2022 té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– 2022 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2929</TotalTime>
  <Words>551</Words>
  <Application>Microsoft Office PowerPoint</Application>
  <PresentationFormat>A4 Paper (210x297 mm)</PresentationFormat>
  <Paragraphs>16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Arial</vt:lpstr>
      <vt:lpstr>Calibri</vt:lpstr>
      <vt:lpstr>Calibri Light</vt:lpstr>
      <vt:lpstr>Palatino Linotype</vt:lpstr>
      <vt:lpstr>Times New Roman</vt:lpstr>
      <vt:lpstr>Office 2013 – 2022 téma</vt:lpstr>
      <vt:lpstr>Prism 9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Windows-felhasználó</dc:creator>
  <cp:lastModifiedBy>MDPI</cp:lastModifiedBy>
  <cp:revision>18</cp:revision>
  <dcterms:created xsi:type="dcterms:W3CDTF">2025-05-08T13:17:45Z</dcterms:created>
  <dcterms:modified xsi:type="dcterms:W3CDTF">2025-09-20T09:09:44Z</dcterms:modified>
</cp:coreProperties>
</file>